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  <p:sldId id="258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666" y="-23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1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Liu Qing\膀胱癌新思路\文章图\补充图\补充材料图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3237" y="70673"/>
            <a:ext cx="4289493" cy="61356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矩形 6"/>
          <p:cNvSpPr/>
          <p:nvPr/>
        </p:nvSpPr>
        <p:spPr>
          <a:xfrm>
            <a:off x="107504" y="6206311"/>
            <a:ext cx="864096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Figure S1 The results from </a:t>
            </a:r>
            <a:r>
              <a:rPr lang="en-US" altLang="zh-CN" kern="100" dirty="0" err="1">
                <a:latin typeface="Times New Roman"/>
                <a:cs typeface="Times New Roman"/>
              </a:rPr>
              <a:t>MCPcounter</a:t>
            </a:r>
            <a:r>
              <a:rPr lang="en-US" altLang="zh-CN" kern="100" dirty="0">
                <a:latin typeface="Times New Roman"/>
                <a:cs typeface="Times New Roman"/>
              </a:rPr>
              <a:t> method validated the population abundance of tissue-infiltrating immune and stromal cell populations in two subtypes.</a:t>
            </a:r>
            <a:endParaRPr lang="zh-CN" altLang="zh-CN" sz="1400" kern="100" dirty="0"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8174462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F:\Liu Qing\膀胱癌新思路\文章图\补充图\补充材料图2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0"/>
            <a:ext cx="7918056" cy="60110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矩形 1"/>
          <p:cNvSpPr/>
          <p:nvPr/>
        </p:nvSpPr>
        <p:spPr>
          <a:xfrm>
            <a:off x="251520" y="6056421"/>
            <a:ext cx="88924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Figure S2 The immunologic prognostic risk model had better predictive power and accuracy compared with age, gender, grade, stage.</a:t>
            </a:r>
            <a:endParaRPr lang="zh-CN" altLang="zh-CN" sz="1400" kern="100" dirty="0"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6478199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Liu Qing\膀胱癌新思路\文章图\Figure GEO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5656" y="-18296"/>
            <a:ext cx="5943600" cy="5029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矩形 2"/>
          <p:cNvSpPr/>
          <p:nvPr/>
        </p:nvSpPr>
        <p:spPr>
          <a:xfrm>
            <a:off x="395536" y="5301208"/>
            <a:ext cx="849694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Figure S3 Kaplan-Meier analysis showed that the low-risk group has a greater chance of obtaining the same survival time than the higher risk score group in GEO dataset.</a:t>
            </a:r>
            <a:endParaRPr lang="zh-CN" altLang="zh-CN" sz="1400" kern="100" dirty="0"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531676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74</Words>
  <Application>Microsoft Office PowerPoint</Application>
  <PresentationFormat>全屏显示(4:3)</PresentationFormat>
  <Paragraphs>3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dell</cp:lastModifiedBy>
  <cp:revision>16</cp:revision>
  <dcterms:created xsi:type="dcterms:W3CDTF">2021-11-08T08:17:41Z</dcterms:created>
  <dcterms:modified xsi:type="dcterms:W3CDTF">2021-12-16T09:43:31Z</dcterms:modified>
</cp:coreProperties>
</file>